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23" r:id="rId2"/>
  </p:sldIdLst>
  <p:sldSz cx="12192000" cy="6858000"/>
  <p:notesSz cx="7023100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almbos, Phillip" initials="PP" lastIdx="2" clrIdx="0">
    <p:extLst>
      <p:ext uri="{19B8F6BF-5375-455C-9EA6-DF929625EA0E}">
        <p15:presenceInfo xmlns:p15="http://schemas.microsoft.com/office/powerpoint/2012/main" userId="S::ppalmbos@med.umich.edu::a5e960cb-cae3-4151-b0b6-8d6bf87668c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868" autoAdjust="0"/>
    <p:restoredTop sz="93457" autoAdjust="0"/>
  </p:normalViewPr>
  <p:slideViewPr>
    <p:cSldViewPr snapToGrid="0">
      <p:cViewPr varScale="1">
        <p:scale>
          <a:sx n="124" d="100"/>
          <a:sy n="124" d="100"/>
        </p:scale>
        <p:origin x="400" y="168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-332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4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1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F85BD-F988-46E5-A585-2B686D85E9B6}" type="datetimeFigureOut">
              <a:rPr lang="en-US" smtClean="0"/>
              <a:pPr/>
              <a:t>7/2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719B8-8C36-48CC-A173-9F46CB3AA4F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47915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F85BD-F988-46E5-A585-2B686D85E9B6}" type="datetimeFigureOut">
              <a:rPr lang="en-US" smtClean="0"/>
              <a:pPr/>
              <a:t>7/2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719B8-8C36-48CC-A173-9F46CB3AA4F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2979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899" y="365126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199" y="365126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F85BD-F988-46E5-A585-2B686D85E9B6}" type="datetimeFigureOut">
              <a:rPr lang="en-US" smtClean="0"/>
              <a:pPr/>
              <a:t>7/2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719B8-8C36-48CC-A173-9F46CB3AA4F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6255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F85BD-F988-46E5-A585-2B686D85E9B6}" type="datetimeFigureOut">
              <a:rPr lang="en-US" smtClean="0"/>
              <a:pPr/>
              <a:t>7/2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719B8-8C36-48CC-A173-9F46CB3AA4F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72389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2" y="1709739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F85BD-F988-46E5-A585-2B686D85E9B6}" type="datetimeFigureOut">
              <a:rPr lang="en-US" smtClean="0"/>
              <a:pPr/>
              <a:t>7/2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719B8-8C36-48CC-A173-9F46CB3AA4F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76609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F85BD-F988-46E5-A585-2B686D85E9B6}" type="datetimeFigureOut">
              <a:rPr lang="en-US" smtClean="0"/>
              <a:pPr/>
              <a:t>7/22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719B8-8C36-48CC-A173-9F46CB3AA4F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87811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65126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4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1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4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1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F85BD-F988-46E5-A585-2B686D85E9B6}" type="datetimeFigureOut">
              <a:rPr lang="en-US" smtClean="0"/>
              <a:pPr/>
              <a:t>7/22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719B8-8C36-48CC-A173-9F46CB3AA4F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05893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F85BD-F988-46E5-A585-2B686D85E9B6}" type="datetimeFigureOut">
              <a:rPr lang="en-US" smtClean="0"/>
              <a:pPr/>
              <a:t>7/22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719B8-8C36-48CC-A173-9F46CB3AA4F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3282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F85BD-F988-46E5-A585-2B686D85E9B6}" type="datetimeFigureOut">
              <a:rPr lang="en-US" smtClean="0"/>
              <a:pPr/>
              <a:t>7/22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719B8-8C36-48CC-A173-9F46CB3AA4F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67778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6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1"/>
            </a:lvl2pPr>
            <a:lvl3pPr marL="914411" indent="0">
              <a:buNone/>
              <a:defRPr sz="1200"/>
            </a:lvl3pPr>
            <a:lvl4pPr marL="1371617" indent="0">
              <a:buNone/>
              <a:defRPr sz="1001"/>
            </a:lvl4pPr>
            <a:lvl5pPr marL="1828823" indent="0">
              <a:buNone/>
              <a:defRPr sz="1001"/>
            </a:lvl5pPr>
            <a:lvl6pPr marL="2286029" indent="0">
              <a:buNone/>
              <a:defRPr sz="1001"/>
            </a:lvl6pPr>
            <a:lvl7pPr marL="2743234" indent="0">
              <a:buNone/>
              <a:defRPr sz="1001"/>
            </a:lvl7pPr>
            <a:lvl8pPr marL="3200440" indent="0">
              <a:buNone/>
              <a:defRPr sz="1001"/>
            </a:lvl8pPr>
            <a:lvl9pPr marL="3657646" indent="0">
              <a:buNone/>
              <a:defRPr sz="100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F85BD-F988-46E5-A585-2B686D85E9B6}" type="datetimeFigureOut">
              <a:rPr lang="en-US" smtClean="0"/>
              <a:pPr/>
              <a:t>7/22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719B8-8C36-48CC-A173-9F46CB3AA4F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65055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6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1"/>
            </a:lvl2pPr>
            <a:lvl3pPr marL="914411" indent="0">
              <a:buNone/>
              <a:defRPr sz="1200"/>
            </a:lvl3pPr>
            <a:lvl4pPr marL="1371617" indent="0">
              <a:buNone/>
              <a:defRPr sz="1001"/>
            </a:lvl4pPr>
            <a:lvl5pPr marL="1828823" indent="0">
              <a:buNone/>
              <a:defRPr sz="1001"/>
            </a:lvl5pPr>
            <a:lvl6pPr marL="2286029" indent="0">
              <a:buNone/>
              <a:defRPr sz="1001"/>
            </a:lvl6pPr>
            <a:lvl7pPr marL="2743234" indent="0">
              <a:buNone/>
              <a:defRPr sz="1001"/>
            </a:lvl7pPr>
            <a:lvl8pPr marL="3200440" indent="0">
              <a:buNone/>
              <a:defRPr sz="1001"/>
            </a:lvl8pPr>
            <a:lvl9pPr marL="3657646" indent="0">
              <a:buNone/>
              <a:defRPr sz="100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F85BD-F988-46E5-A585-2B686D85E9B6}" type="datetimeFigureOut">
              <a:rPr lang="en-US" smtClean="0"/>
              <a:pPr/>
              <a:t>7/22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719B8-8C36-48CC-A173-9F46CB3AA4F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80164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2" y="365126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7F85BD-F988-46E5-A585-2B686D85E9B6}" type="datetimeFigureOut">
              <a:rPr lang="en-US" smtClean="0"/>
              <a:pPr/>
              <a:t>7/2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6719B8-8C36-48CC-A173-9F46CB3AA4F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04691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4" indent="-228604" algn="l" defTabSz="914411" rtl="0" eaLnBrk="1" latinLnBrk="0" hangingPunct="1">
        <a:lnSpc>
          <a:spcPct val="90000"/>
        </a:lnSpc>
        <a:spcBef>
          <a:spcPts val="1001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9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5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1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7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8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4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9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940660A8-ABF7-4545-8D52-D60F034C401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0211953"/>
              </p:ext>
            </p:extLst>
          </p:nvPr>
        </p:nvGraphicFramePr>
        <p:xfrm>
          <a:off x="240922" y="1114566"/>
          <a:ext cx="3739351" cy="5080680"/>
        </p:xfrm>
        <a:graphic>
          <a:graphicData uri="http://schemas.openxmlformats.org/drawingml/2006/table">
            <a:tbl>
              <a:tblPr firstRow="1" bandRow="1">
                <a:tableStyleId>{616DA210-FB5B-4158-B5E0-FEB733F419BA}</a:tableStyleId>
              </a:tblPr>
              <a:tblGrid>
                <a:gridCol w="1799268">
                  <a:extLst>
                    <a:ext uri="{9D8B030D-6E8A-4147-A177-3AD203B41FA5}">
                      <a16:colId xmlns:a16="http://schemas.microsoft.com/office/drawing/2014/main" val="1669034230"/>
                    </a:ext>
                  </a:extLst>
                </a:gridCol>
                <a:gridCol w="797952">
                  <a:extLst>
                    <a:ext uri="{9D8B030D-6E8A-4147-A177-3AD203B41FA5}">
                      <a16:colId xmlns:a16="http://schemas.microsoft.com/office/drawing/2014/main" val="1074618809"/>
                    </a:ext>
                  </a:extLst>
                </a:gridCol>
                <a:gridCol w="429151">
                  <a:extLst>
                    <a:ext uri="{9D8B030D-6E8A-4147-A177-3AD203B41FA5}">
                      <a16:colId xmlns:a16="http://schemas.microsoft.com/office/drawing/2014/main" val="804786353"/>
                    </a:ext>
                  </a:extLst>
                </a:gridCol>
                <a:gridCol w="350926">
                  <a:extLst>
                    <a:ext uri="{9D8B030D-6E8A-4147-A177-3AD203B41FA5}">
                      <a16:colId xmlns:a16="http://schemas.microsoft.com/office/drawing/2014/main" val="2044088322"/>
                    </a:ext>
                  </a:extLst>
                </a:gridCol>
                <a:gridCol w="362054">
                  <a:extLst>
                    <a:ext uri="{9D8B030D-6E8A-4147-A177-3AD203B41FA5}">
                      <a16:colId xmlns:a16="http://schemas.microsoft.com/office/drawing/2014/main" val="2966463835"/>
                    </a:ext>
                  </a:extLst>
                </a:gridCol>
              </a:tblGrid>
              <a:tr h="20713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KEGG Gene Set Name [# Genes]</a:t>
                      </a:r>
                      <a:endParaRPr lang="en-US" sz="8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Description</a:t>
                      </a:r>
                      <a:endParaRPr lang="en-US" sz="8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# Genes in Overlap</a:t>
                      </a:r>
                      <a:endParaRPr lang="en-US" sz="8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p-value </a:t>
                      </a:r>
                      <a:endParaRPr lang="en-US" sz="8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FDR q-value </a:t>
                      </a:r>
                      <a:endParaRPr lang="en-US" sz="8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69410383"/>
                  </a:ext>
                </a:extLst>
              </a:tr>
              <a:tr h="14740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RIBOSOME [88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Ribosome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70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3.9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92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7.26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90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868773342"/>
                  </a:ext>
                </a:extLst>
              </a:tr>
              <a:tr h="14740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TIGHT_JUNCTION [132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Tight junction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42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1.44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32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1.34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30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3698708653"/>
                  </a:ext>
                </a:extLst>
              </a:tr>
              <a:tr h="2086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sng" strike="noStrike" dirty="0">
                          <a:solidFill>
                            <a:schemeClr val="tx1"/>
                          </a:solidFill>
                          <a:effectLst/>
                        </a:rPr>
                        <a:t>REGULATION_OF_ACTIN_CYTOSKELETON [213]</a:t>
                      </a:r>
                      <a:endParaRPr lang="en-US" sz="800" b="1" i="0" u="sng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Regulation of actin cytoskeleton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46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2.22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27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1.38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25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469253998"/>
                  </a:ext>
                </a:extLst>
              </a:tr>
              <a:tr h="2086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PATHOGENIC_ESCHERICHIA_COLI_INFECTION [56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Pathogenic Escherichia coli infection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27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3.06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27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1.42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25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4189627007"/>
                  </a:ext>
                </a:extLst>
              </a:tr>
              <a:tr h="14740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SPLICEOSOME [127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Spliceosome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35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5.53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25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2.06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23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444084683"/>
                  </a:ext>
                </a:extLst>
              </a:tr>
              <a:tr h="14740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ADHERENS_JUNCTION [73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Adherens junction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25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7.71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21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2.39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19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862711978"/>
                  </a:ext>
                </a:extLst>
              </a:tr>
              <a:tr h="14740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sng" strike="noStrike" dirty="0">
                          <a:solidFill>
                            <a:schemeClr val="tx1"/>
                          </a:solidFill>
                          <a:effectLst/>
                        </a:rPr>
                        <a:t>FOCAL_ADHESION [199]</a:t>
                      </a:r>
                      <a:endParaRPr lang="en-US" sz="800" b="1" i="0" u="sng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Focal adhesion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36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5.06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19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1.34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17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666243"/>
                  </a:ext>
                </a:extLst>
              </a:tr>
              <a:tr h="31070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ARRHYTHMOGENIC_RIGHT_VENTRICULAR_CARDIOMYOPATHY_ARVC [74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Arrhythmogenic right ventricular cardiomyopathy (ARVC)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22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5.27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17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1.23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15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184300765"/>
                  </a:ext>
                </a:extLst>
              </a:tr>
              <a:tr h="14740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ENDOCYTOSIS [181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Endocytosis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32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9.21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17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1.9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15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55819728"/>
                  </a:ext>
                </a:extLst>
              </a:tr>
              <a:tr h="14740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HUNTINGTONS_DISEASE [182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Huntington's disease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32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1.09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16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2.02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15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841277666"/>
                  </a:ext>
                </a:extLst>
              </a:tr>
              <a:tr h="14740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ALZHEIMERS_DISEASE [166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Alzheimer's disease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30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4.48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16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7.58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15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932139767"/>
                  </a:ext>
                </a:extLst>
              </a:tr>
              <a:tr h="14740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GAP_JUNCTION [90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Gap junction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21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5.69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14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8.82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13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3340286915"/>
                  </a:ext>
                </a:extLst>
              </a:tr>
              <a:tr h="31070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LEUKOCYTE_TRANSENDOTHELIAL_MIGRATION [116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Leukocyte transendothelial migration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23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1.51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13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2.16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12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139908689"/>
                  </a:ext>
                </a:extLst>
              </a:tr>
              <a:tr h="2086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HYPERTROPHIC_CARDIOMYOPATHY_HCM [83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Hypertrophic cardiomyopathy (HCM)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19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1.29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12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1.72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11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531669366"/>
                  </a:ext>
                </a:extLst>
              </a:tr>
              <a:tr h="14740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PARKINSONS_DISEASE [130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Parkinson's disease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23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1.87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12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2.32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11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3810313850"/>
                  </a:ext>
                </a:extLst>
              </a:tr>
              <a:tr h="14740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DILATED_CARDIOMYOPATHY [90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Dilated cardiomyopathy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19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6.04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12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7.02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11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424818340"/>
                  </a:ext>
                </a:extLst>
              </a:tr>
              <a:tr h="20713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OXIDATIVE_PHOSPHORYLATION [132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Oxidative phosphorylation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22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1.94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11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2.12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10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607804982"/>
                  </a:ext>
                </a:extLst>
              </a:tr>
              <a:tr h="2086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CARDIAC_MUSCLE_CONTRACTION [79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Cardiac muscle contraction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17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5.64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11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5.83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10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3321523507"/>
                  </a:ext>
                </a:extLst>
              </a:tr>
              <a:tr h="14740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AXON_GUIDANCE [129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Axon guidance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21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8.74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11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8.56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10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536376997"/>
                  </a:ext>
                </a:extLst>
              </a:tr>
              <a:tr h="20713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ECM_RECEPTOR_INTERACTION [84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ECM-receptor interaction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17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1.58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10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1.47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9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413425614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157A3FA8-0E10-1D40-84C8-E1CF1572DB92}"/>
              </a:ext>
            </a:extLst>
          </p:cNvPr>
          <p:cNvSpPr txBox="1"/>
          <p:nvPr/>
        </p:nvSpPr>
        <p:spPr>
          <a:xfrm>
            <a:off x="464342" y="132364"/>
            <a:ext cx="11483921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1" dirty="0">
                <a:latin typeface="Arial" panose="020B0604020202020204" pitchFamily="34" charset="0"/>
                <a:cs typeface="Arial" panose="020B0604020202020204" pitchFamily="34" charset="0"/>
              </a:rPr>
              <a:t>Supplemental Table 2. KEGG Pathway Analysis of TRIM29 Interacting Proteins Identified by Mass Spec. </a:t>
            </a:r>
          </a:p>
        </p:txBody>
      </p:sp>
      <p:graphicFrame>
        <p:nvGraphicFramePr>
          <p:cNvPr id="4" name="Table 2">
            <a:extLst>
              <a:ext uri="{FF2B5EF4-FFF2-40B4-BE49-F238E27FC236}">
                <a16:creationId xmlns:a16="http://schemas.microsoft.com/office/drawing/2014/main" id="{E1CAEC10-7E5E-454F-BD07-DC2D86F30DC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3380476"/>
              </p:ext>
            </p:extLst>
          </p:nvPr>
        </p:nvGraphicFramePr>
        <p:xfrm>
          <a:off x="4140930" y="1122692"/>
          <a:ext cx="3739350" cy="5072555"/>
        </p:xfrm>
        <a:graphic>
          <a:graphicData uri="http://schemas.openxmlformats.org/drawingml/2006/table">
            <a:tbl>
              <a:tblPr firstRow="1" bandRow="1">
                <a:tableStyleId>{616DA210-FB5B-4158-B5E0-FEB733F419BA}</a:tableStyleId>
              </a:tblPr>
              <a:tblGrid>
                <a:gridCol w="1805975">
                  <a:extLst>
                    <a:ext uri="{9D8B030D-6E8A-4147-A177-3AD203B41FA5}">
                      <a16:colId xmlns:a16="http://schemas.microsoft.com/office/drawing/2014/main" val="1669034230"/>
                    </a:ext>
                  </a:extLst>
                </a:gridCol>
                <a:gridCol w="797952">
                  <a:extLst>
                    <a:ext uri="{9D8B030D-6E8A-4147-A177-3AD203B41FA5}">
                      <a16:colId xmlns:a16="http://schemas.microsoft.com/office/drawing/2014/main" val="3235437174"/>
                    </a:ext>
                  </a:extLst>
                </a:gridCol>
                <a:gridCol w="422444">
                  <a:extLst>
                    <a:ext uri="{9D8B030D-6E8A-4147-A177-3AD203B41FA5}">
                      <a16:colId xmlns:a16="http://schemas.microsoft.com/office/drawing/2014/main" val="1074618809"/>
                    </a:ext>
                  </a:extLst>
                </a:gridCol>
                <a:gridCol w="348685">
                  <a:extLst>
                    <a:ext uri="{9D8B030D-6E8A-4147-A177-3AD203B41FA5}">
                      <a16:colId xmlns:a16="http://schemas.microsoft.com/office/drawing/2014/main" val="2044088322"/>
                    </a:ext>
                  </a:extLst>
                </a:gridCol>
                <a:gridCol w="364294">
                  <a:extLst>
                    <a:ext uri="{9D8B030D-6E8A-4147-A177-3AD203B41FA5}">
                      <a16:colId xmlns:a16="http://schemas.microsoft.com/office/drawing/2014/main" val="2966463835"/>
                    </a:ext>
                  </a:extLst>
                </a:gridCol>
              </a:tblGrid>
              <a:tr h="38315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KEGG Gene Set Name [# Genes]</a:t>
                      </a:r>
                      <a:endParaRPr lang="en-US" sz="8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Description</a:t>
                      </a:r>
                      <a:endParaRPr lang="en-US" sz="8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# Genes in Overlap</a:t>
                      </a:r>
                      <a:endParaRPr lang="en-US" sz="8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p-value </a:t>
                      </a:r>
                      <a:endParaRPr lang="en-US" sz="8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FDR q-value </a:t>
                      </a:r>
                      <a:endParaRPr lang="en-US" sz="8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69410383"/>
                  </a:ext>
                </a:extLst>
              </a:tr>
              <a:tr h="26541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HUNTINGTONS_DISEASE [182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Huntington's disease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17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8.47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15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1.58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12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68773342"/>
                  </a:ext>
                </a:extLst>
              </a:tr>
              <a:tr h="26541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ALZHEIMERS_DISEASE [166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Alzheimer's disease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15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5.37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13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4.99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11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98708653"/>
                  </a:ext>
                </a:extLst>
              </a:tr>
              <a:tr h="26541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PARKINSONS_DISEASE [130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Parkinson's disease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12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9.13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11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5.66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9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69253998"/>
                  </a:ext>
                </a:extLst>
              </a:tr>
              <a:tr h="26541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OXIDATIVE_PHOSPHORYLATION [132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Oxidative phosphorylation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11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1.68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9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7.81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8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89627007"/>
                  </a:ext>
                </a:extLst>
              </a:tr>
              <a:tr h="17108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TIGHT_JUNCTION [132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Tight junction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9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2.94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7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1.09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5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44084683"/>
                  </a:ext>
                </a:extLst>
              </a:tr>
              <a:tr h="17108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MELANOGENESIS [101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Melanogenesis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8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4.31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7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1.24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5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62711978"/>
                  </a:ext>
                </a:extLst>
              </a:tr>
              <a:tr h="26541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LONG_TERM_DEPRESSION [70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Long-term depression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7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4.68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7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1.24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5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66243"/>
                  </a:ext>
                </a:extLst>
              </a:tr>
              <a:tr h="26541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ECM_RECEPTOR_INTERACTION [84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ECM-receptor interaction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7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1.63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6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3.79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5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84300765"/>
                  </a:ext>
                </a:extLst>
              </a:tr>
              <a:tr h="17108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RIBOSOME [88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Ribosome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7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2.24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6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4.62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5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5819728"/>
                  </a:ext>
                </a:extLst>
              </a:tr>
              <a:tr h="17108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GAP_JUNCTION [90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Gap junction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7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2.6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6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4.84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5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41277666"/>
                  </a:ext>
                </a:extLst>
              </a:tr>
              <a:tr h="39313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FC_GAMMA_R_MEDIATED_PHAGOCYTOSIS [96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Fc gamma R-mediated phagocytosis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7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4.01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6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6.78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5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32139767"/>
                  </a:ext>
                </a:extLst>
              </a:tr>
              <a:tr h="26541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LONG_TERM_POTENTIATION [70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Long-term potentiation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6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7.82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6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1.21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4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40286915"/>
                  </a:ext>
                </a:extLst>
              </a:tr>
              <a:tr h="26541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sng" strike="noStrike" dirty="0">
                          <a:solidFill>
                            <a:schemeClr val="tx1"/>
                          </a:solidFill>
                          <a:effectLst/>
                        </a:rPr>
                        <a:t>REGULATION_OF_ACTIN_CYTOSKELETON [213]</a:t>
                      </a:r>
                      <a:endParaRPr lang="en-US" sz="800" b="1" i="0" u="sng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Regulation of actin cytoskeleton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9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1.52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5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2.17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4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39908689"/>
                  </a:ext>
                </a:extLst>
              </a:tr>
              <a:tr h="1791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ENDOCYTOSIS [181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Endocytosis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8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3.29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5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4.37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4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31669366"/>
                  </a:ext>
                </a:extLst>
              </a:tr>
              <a:tr h="26541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PHOSPHATIDYLINOSITOL_SIGNALING_SYSTEM [76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Phosphatidylinositol signaling system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5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1.63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4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2.02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3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10313850"/>
                  </a:ext>
                </a:extLst>
              </a:tr>
              <a:tr h="17108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AXON_GUIDANCE [129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Axon guidance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6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2.44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4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2.84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3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24818340"/>
                  </a:ext>
                </a:extLst>
              </a:tr>
              <a:tr h="17108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sng" strike="noStrike" dirty="0">
                          <a:solidFill>
                            <a:schemeClr val="tx1"/>
                          </a:solidFill>
                          <a:effectLst/>
                        </a:rPr>
                        <a:t>FOCAL_ADHESION [199]</a:t>
                      </a:r>
                      <a:endParaRPr lang="en-US" sz="800" b="1" i="0" u="sng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Focal adhesion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7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4.14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4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4.53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3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07804982"/>
                  </a:ext>
                </a:extLst>
              </a:tr>
              <a:tr h="26541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NITROGEN_METABOLISM [23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Nitrogen metabolism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4.77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4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4.92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3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21523507"/>
                  </a:ext>
                </a:extLst>
              </a:tr>
              <a:tr h="17108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PROTEIN_EXPORT [24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Protein export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5.42 e</a:t>
                      </a:r>
                      <a:r>
                        <a:rPr lang="en-US" sz="800" b="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-4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5.3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3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36376997"/>
                  </a:ext>
                </a:extLst>
              </a:tr>
              <a:tr h="26541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GNRH_SIGNALING_PATHWAY [101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GnRH signaling pathway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5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6.09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4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5.67 e</a:t>
                      </a:r>
                      <a:r>
                        <a:rPr lang="en-US" sz="800" b="0" u="none" strike="noStrike" baseline="30000" dirty="0">
                          <a:solidFill>
                            <a:schemeClr val="tx1"/>
                          </a:solidFill>
                          <a:effectLst/>
                        </a:rPr>
                        <a:t>-3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3425614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103ABF01-3D15-E148-94A3-91DA1DC79E65}"/>
              </a:ext>
            </a:extLst>
          </p:cNvPr>
          <p:cNvSpPr txBox="1"/>
          <p:nvPr/>
        </p:nvSpPr>
        <p:spPr>
          <a:xfrm>
            <a:off x="1189519" y="736543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UM-UC5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BBB815F-2A27-D947-ADBA-9C0818C1EBAA}"/>
              </a:ext>
            </a:extLst>
          </p:cNvPr>
          <p:cNvSpPr txBox="1"/>
          <p:nvPr/>
        </p:nvSpPr>
        <p:spPr>
          <a:xfrm>
            <a:off x="5284985" y="745234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UM-UC9</a:t>
            </a:r>
          </a:p>
        </p:txBody>
      </p:sp>
      <p:graphicFrame>
        <p:nvGraphicFramePr>
          <p:cNvPr id="8" name="Table 2">
            <a:extLst>
              <a:ext uri="{FF2B5EF4-FFF2-40B4-BE49-F238E27FC236}">
                <a16:creationId xmlns:a16="http://schemas.microsoft.com/office/drawing/2014/main" id="{696C12D0-F508-5A1C-F5CB-BB81E5DB188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04262326"/>
              </p:ext>
            </p:extLst>
          </p:nvPr>
        </p:nvGraphicFramePr>
        <p:xfrm>
          <a:off x="8012582" y="1110708"/>
          <a:ext cx="3739350" cy="5328292"/>
        </p:xfrm>
        <a:graphic>
          <a:graphicData uri="http://schemas.openxmlformats.org/drawingml/2006/table">
            <a:tbl>
              <a:tblPr firstRow="1" bandRow="1">
                <a:tableStyleId>{616DA210-FB5B-4158-B5E0-FEB733F419BA}</a:tableStyleId>
              </a:tblPr>
              <a:tblGrid>
                <a:gridCol w="1805975">
                  <a:extLst>
                    <a:ext uri="{9D8B030D-6E8A-4147-A177-3AD203B41FA5}">
                      <a16:colId xmlns:a16="http://schemas.microsoft.com/office/drawing/2014/main" val="1669034230"/>
                    </a:ext>
                  </a:extLst>
                </a:gridCol>
                <a:gridCol w="797952">
                  <a:extLst>
                    <a:ext uri="{9D8B030D-6E8A-4147-A177-3AD203B41FA5}">
                      <a16:colId xmlns:a16="http://schemas.microsoft.com/office/drawing/2014/main" val="3235437174"/>
                    </a:ext>
                  </a:extLst>
                </a:gridCol>
                <a:gridCol w="359466">
                  <a:extLst>
                    <a:ext uri="{9D8B030D-6E8A-4147-A177-3AD203B41FA5}">
                      <a16:colId xmlns:a16="http://schemas.microsoft.com/office/drawing/2014/main" val="1074618809"/>
                    </a:ext>
                  </a:extLst>
                </a:gridCol>
                <a:gridCol w="411663">
                  <a:extLst>
                    <a:ext uri="{9D8B030D-6E8A-4147-A177-3AD203B41FA5}">
                      <a16:colId xmlns:a16="http://schemas.microsoft.com/office/drawing/2014/main" val="2044088322"/>
                    </a:ext>
                  </a:extLst>
                </a:gridCol>
                <a:gridCol w="364294">
                  <a:extLst>
                    <a:ext uri="{9D8B030D-6E8A-4147-A177-3AD203B41FA5}">
                      <a16:colId xmlns:a16="http://schemas.microsoft.com/office/drawing/2014/main" val="2966463835"/>
                    </a:ext>
                  </a:extLst>
                </a:gridCol>
              </a:tblGrid>
              <a:tr h="34326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KEGG Gene Set Name [# Genes]</a:t>
                      </a:r>
                      <a:endParaRPr lang="en-US" sz="8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Description</a:t>
                      </a:r>
                      <a:endParaRPr lang="en-US" sz="8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# Genes in Overlap</a:t>
                      </a:r>
                      <a:endParaRPr lang="en-US" sz="8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p-value </a:t>
                      </a:r>
                      <a:endParaRPr lang="en-US" sz="8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FDR q-value </a:t>
                      </a:r>
                      <a:endParaRPr lang="en-US" sz="8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69410383"/>
                  </a:ext>
                </a:extLst>
              </a:tr>
              <a:tr h="23778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HUNTINGTONS_DISEASE [182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Huntington's disease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4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11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1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06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1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68773342"/>
                  </a:ext>
                </a:extLst>
              </a:tr>
              <a:tr h="23778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ALZHEIMERS_DISEASE [166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Alzheimer's disease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2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75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1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56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98708653"/>
                  </a:ext>
                </a:extLst>
              </a:tr>
              <a:tr h="23778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PARKINSONS_DISEASE [130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Parkinson's disease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0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52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.43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1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69253998"/>
                  </a:ext>
                </a:extLst>
              </a:tr>
              <a:tr h="23778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OXIDATIVE_PHOSPHORYLATION [132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Oxidative phosphorylation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82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1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24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89627007"/>
                  </a:ext>
                </a:extLst>
              </a:tr>
              <a:tr h="14625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MELANOGENESIS [101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Melanogenesis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39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15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44084683"/>
                  </a:ext>
                </a:extLst>
              </a:tr>
              <a:tr h="146254">
                <a:tc>
                  <a:txBody>
                    <a:bodyPr/>
                    <a:lstStyle/>
                    <a:p>
                      <a:pPr marL="0" marR="0" lvl="0" indent="0" algn="l" defTabSz="914411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TIGHT_JUNCTION [132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l" defTabSz="914411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Tight junction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16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.6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62711978"/>
                  </a:ext>
                </a:extLst>
              </a:tr>
              <a:tr h="23778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LONG_TERM_DEPRESSION [70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>
                          <a:solidFill>
                            <a:schemeClr val="tx1"/>
                          </a:solidFill>
                          <a:effectLst/>
                        </a:rPr>
                        <a:t>Long-term depression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05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8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66243"/>
                  </a:ext>
                </a:extLst>
              </a:tr>
              <a:tr h="226892">
                <a:tc>
                  <a:txBody>
                    <a:bodyPr/>
                    <a:lstStyle/>
                    <a:p>
                      <a:pPr marL="0" marR="0" lvl="0" indent="0" algn="l" defTabSz="914411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GAP_JUNCTION [90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l" defTabSz="914411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Gap junction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75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1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84300765"/>
                  </a:ext>
                </a:extLst>
              </a:tr>
              <a:tr h="237780">
                <a:tc>
                  <a:txBody>
                    <a:bodyPr/>
                    <a:lstStyle/>
                    <a:p>
                      <a:pPr marL="0" marR="0" lvl="0" indent="0" algn="l" defTabSz="914411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LONG_TERM_POTENTIATION [70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l" defTabSz="914411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Long-term potentiation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.16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.54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5819728"/>
                  </a:ext>
                </a:extLst>
              </a:tr>
              <a:tr h="146254">
                <a:tc>
                  <a:txBody>
                    <a:bodyPr/>
                    <a:lstStyle/>
                    <a:p>
                      <a:pPr marL="0" marR="0" lvl="0" indent="0" algn="l" defTabSz="914411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AXON_GUIDANCE [129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l" defTabSz="914411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Axon guidance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.92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.29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41277666"/>
                  </a:ext>
                </a:extLst>
              </a:tr>
              <a:tr h="183589">
                <a:tc>
                  <a:txBody>
                    <a:bodyPr/>
                    <a:lstStyle/>
                    <a:p>
                      <a:pPr marL="0" marR="0" lvl="0" indent="0" algn="l" defTabSz="914411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ENDOCYTOSIS [181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l" defTabSz="914411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Endocytosis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7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57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32139767"/>
                  </a:ext>
                </a:extLst>
              </a:tr>
              <a:tr h="237780">
                <a:tc>
                  <a:txBody>
                    <a:bodyPr/>
                    <a:lstStyle/>
                    <a:p>
                      <a:pPr marL="0" marR="0" lvl="0" indent="0" algn="l" defTabSz="914411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u="sng" strike="noStrike" dirty="0">
                          <a:solidFill>
                            <a:schemeClr val="tx1"/>
                          </a:solidFill>
                          <a:effectLst/>
                        </a:rPr>
                        <a:t>REGULATION_OF_ACTIN_CYTOSKELETON [213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l" defTabSz="914411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Regulation of actin cytoskeleton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.69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04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40286915"/>
                  </a:ext>
                </a:extLst>
              </a:tr>
              <a:tr h="226892">
                <a:tc>
                  <a:txBody>
                    <a:bodyPr/>
                    <a:lstStyle/>
                    <a:p>
                      <a:pPr marL="0" marR="0" lvl="0" indent="0" algn="l" defTabSz="914411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RIBOSOME [88]</a:t>
                      </a:r>
                      <a:endParaRPr lang="en-US" sz="800" b="1" i="0" u="sng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l" defTabSz="914411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Ribosome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89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7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39908689"/>
                  </a:ext>
                </a:extLst>
              </a:tr>
              <a:tr h="352200">
                <a:tc>
                  <a:txBody>
                    <a:bodyPr/>
                    <a:lstStyle/>
                    <a:p>
                      <a:pPr marL="0" marR="0" lvl="0" indent="0" algn="l" defTabSz="914411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FC_GAMMA_R_MEDIATED_PHAGOCYTOSIS [96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l" defTabSz="914411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Fc gamma R-mediated phagocytosis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63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.46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31669366"/>
                  </a:ext>
                </a:extLst>
              </a:tr>
              <a:tr h="23778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CALCIUM_SIGNALING PATHWAY [178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Calcium Signaling Pathway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79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.46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10313850"/>
                  </a:ext>
                </a:extLst>
              </a:tr>
              <a:tr h="237780">
                <a:tc>
                  <a:txBody>
                    <a:bodyPr/>
                    <a:lstStyle/>
                    <a:p>
                      <a:pPr marL="0" marR="0" lvl="0" indent="0" algn="l" defTabSz="914411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GNRH_SIGNALING_PATHWAY [101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l" defTabSz="914411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GnRH signaling pathway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.2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.72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24818340"/>
                  </a:ext>
                </a:extLst>
              </a:tr>
              <a:tr h="23778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CHEMOKINE_SIGNALING_PATHWAY [188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Chemokine signaling pathway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.59 e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.93 e</a:t>
                      </a:r>
                      <a:r>
                        <a:rPr lang="en-US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07804982"/>
                  </a:ext>
                </a:extLst>
              </a:tr>
              <a:tr h="3522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VASCULAR_SMOOTH_MUSCLE_CONTRACTION [115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Vascular Smooth Muscle Contraction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23 e</a:t>
                      </a:r>
                      <a:r>
                        <a:rPr lang="en-US" sz="9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29 e</a:t>
                      </a:r>
                      <a:r>
                        <a:rPr lang="en-US" sz="9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21523507"/>
                  </a:ext>
                </a:extLst>
              </a:tr>
              <a:tr h="3522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LEUKOCYTE_TRANSENDOTHELIAL_MIGRATION [116]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Leukocyte </a:t>
                      </a:r>
                      <a:r>
                        <a:rPr lang="en-US" sz="800" b="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Transendothelial</a:t>
                      </a:r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 Migration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41 e</a:t>
                      </a:r>
                      <a:r>
                        <a:rPr lang="en-US" sz="9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29 e</a:t>
                      </a:r>
                      <a:r>
                        <a:rPr lang="en-US" sz="9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36376997"/>
                  </a:ext>
                </a:extLst>
              </a:tr>
              <a:tr h="22689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SPLICEOSOME [127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Spliceosom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.59 e</a:t>
                      </a:r>
                      <a:r>
                        <a:rPr lang="en-US" sz="9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.06 e</a:t>
                      </a:r>
                      <a:r>
                        <a:rPr lang="en-US" sz="9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3425614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89E7221C-3C2E-F868-ED4B-9C248EDE1B37}"/>
              </a:ext>
            </a:extLst>
          </p:cNvPr>
          <p:cNvSpPr txBox="1"/>
          <p:nvPr/>
        </p:nvSpPr>
        <p:spPr>
          <a:xfrm>
            <a:off x="9385967" y="713286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verlap</a:t>
            </a:r>
          </a:p>
        </p:txBody>
      </p:sp>
    </p:spTree>
    <p:extLst>
      <p:ext uri="{BB962C8B-B14F-4D97-AF65-F5344CB8AC3E}">
        <p14:creationId xmlns:p14="http://schemas.microsoft.com/office/powerpoint/2010/main" val="12343403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004</TotalTime>
  <Words>911</Words>
  <Application>Microsoft Macintosh PowerPoint</Application>
  <PresentationFormat>Widescreen</PresentationFormat>
  <Paragraphs>3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Michigan Health Syste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Yin</dc:creator>
  <cp:lastModifiedBy>Palmbos, Phillip</cp:lastModifiedBy>
  <cp:revision>860</cp:revision>
  <cp:lastPrinted>2025-07-22T17:25:19Z</cp:lastPrinted>
  <dcterms:created xsi:type="dcterms:W3CDTF">2019-07-10T18:31:31Z</dcterms:created>
  <dcterms:modified xsi:type="dcterms:W3CDTF">2025-07-22T17:33:21Z</dcterms:modified>
</cp:coreProperties>
</file>